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pct" ContentType="image/x-pict"/>
  <Override PartName="/ppt/media/image2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B6B1F-D208-40BD-914A-9255D50B62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4155C-2C22-4A56-BA64-88E264E1F1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697482-A0AF-44FF-8DDA-093F2A3EDA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7E0D1-F6C7-44B6-A784-3199FF905F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37FA3-ED36-4CF2-A498-91AD6D5C2C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90AB6-248C-4C1F-A16E-20CFD5017F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DCAE94-2B99-4EAF-8D6A-85E5A1ACE6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C4754-A754-49D7-BCA6-CA9FC781F3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55005-F781-44C3-8403-1F447BBE59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9B8D69-6C6F-43C8-88E7-588496546F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7FEC1-6CF1-4E9E-A3E7-19C4CE4895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0DA2EE-7B4E-4577-BADE-6BFB4D22D3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3D8627-A5CD-4F9A-8888-7DA2F2717FB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ct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876920" y="6172200"/>
          <a:ext cx="609480" cy="365040"/>
        </p:xfrm>
        <a:graphic>
          <a:graphicData uri="http://schemas.openxmlformats.org/drawingml/2006/table">
            <a:tbl>
              <a:tblPr/>
              <a:tblGrid>
                <a:gridCol w="609480"/>
              </a:tblGrid>
              <a:tr h="3650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4419720" y="1592280"/>
          <a:ext cx="3693960" cy="24462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419720" y="1592280"/>
                    <a:ext cx="3693960" cy="2446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4" name=""/>
          <p:cNvGraphicFramePr/>
          <p:nvPr/>
        </p:nvGraphicFramePr>
        <p:xfrm>
          <a:off x="914400" y="1468440"/>
          <a:ext cx="3657600" cy="257004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914400" y="1468440"/>
                    <a:ext cx="3657600" cy="2570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"/>
          <p:cNvSpPr/>
          <p:nvPr/>
        </p:nvSpPr>
        <p:spPr>
          <a:xfrm rot="16200000">
            <a:off x="518040" y="2544840"/>
            <a:ext cx="54504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ΔC</a:t>
            </a: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</a:rPr>
              <a:t>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9676400">
            <a:off x="940320" y="3801600"/>
            <a:ext cx="1461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-cadher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191120" y="5791320"/>
            <a:ext cx="304560" cy="304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9676400">
            <a:off x="1795680" y="3733560"/>
            <a:ext cx="14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α-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209680" y="446076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rot="19676400">
            <a:off x="2583360" y="3733560"/>
            <a:ext cx="148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β-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133800" y="1330200"/>
            <a:ext cx="1047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251.vecto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130560" y="1549440"/>
            <a:ext cx="895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251.Tie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830640" y="132084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8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6843240" y="1506600"/>
            <a:ext cx="106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87 + Ang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990720" y="5197320"/>
            <a:ext cx="7162560" cy="84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l Figure 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Tie2-mediated modulation of adhesive molecules in gliomas at transcriptional levels. qPCR analysis of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) U251.vector and U251.Tie2 and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) U-87 MG cells treated with Ang1 or vehicle showing the expression level of N-cadherin, α-catenin, and β-catenin. Results represent ΔC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</a:rPr>
              <a:t>T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levels (mean ± SEM) over endogenous control GAPDH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213280" y="2270160"/>
            <a:ext cx="58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 = 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317960" y="2041560"/>
            <a:ext cx="58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 = 0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975400" y="1905120"/>
            <a:ext cx="58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 = 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280480" y="2895480"/>
            <a:ext cx="58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 = 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080400" y="2155680"/>
            <a:ext cx="58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 = 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6861600" y="1841400"/>
            <a:ext cx="58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P = 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"/>
          <p:cNvGrpSpPr/>
          <p:nvPr/>
        </p:nvGrpSpPr>
        <p:grpSpPr>
          <a:xfrm>
            <a:off x="1447920" y="2260440"/>
            <a:ext cx="369720" cy="85680"/>
            <a:chOff x="1447920" y="2260440"/>
            <a:chExt cx="369720" cy="85680"/>
          </a:xfrm>
        </p:grpSpPr>
        <p:sp>
          <p:nvSpPr>
            <p:cNvPr id="64" name=""/>
            <p:cNvSpPr/>
            <p:nvPr/>
          </p:nvSpPr>
          <p:spPr>
            <a:xfrm>
              <a:off x="1447920" y="2260440"/>
              <a:ext cx="0" cy="85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447920" y="2260440"/>
              <a:ext cx="369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817640" y="2260440"/>
              <a:ext cx="0" cy="85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"/>
          <p:cNvSpPr/>
          <p:nvPr/>
        </p:nvSpPr>
        <p:spPr>
          <a:xfrm>
            <a:off x="444600" y="1219320"/>
            <a:ext cx="1652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20640"/>
                <a:tab algn="l" pos="1241280"/>
                <a:tab algn="l" pos="1862280"/>
                <a:tab algn="l" pos="2482920"/>
                <a:tab algn="l" pos="3103560"/>
                <a:tab algn="l" pos="3724200"/>
                <a:tab algn="l" pos="4344840"/>
                <a:tab algn="l" pos="4965840"/>
                <a:tab algn="l" pos="5586480"/>
                <a:tab algn="l" pos="6207120"/>
                <a:tab algn="l" pos="6827760"/>
                <a:tab algn="l" pos="7448400"/>
                <a:tab algn="l" pos="8069400"/>
                <a:tab algn="l" pos="8690040"/>
                <a:tab algn="l" pos="9310680"/>
                <a:tab algn="l" pos="9931320"/>
                <a:tab algn="l" pos="105519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559400" y="1219320"/>
            <a:ext cx="1652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620640"/>
                <a:tab algn="l" pos="1241280"/>
                <a:tab algn="l" pos="1862280"/>
                <a:tab algn="l" pos="2482920"/>
                <a:tab algn="l" pos="3103560"/>
                <a:tab algn="l" pos="3724200"/>
                <a:tab algn="l" pos="4344840"/>
                <a:tab algn="l" pos="4965840"/>
                <a:tab algn="l" pos="5586480"/>
                <a:tab algn="l" pos="6207120"/>
                <a:tab algn="l" pos="6827760"/>
                <a:tab algn="l" pos="7448400"/>
                <a:tab algn="l" pos="8069400"/>
                <a:tab algn="l" pos="8690040"/>
                <a:tab algn="l" pos="9310680"/>
                <a:tab algn="l" pos="9931320"/>
                <a:tab algn="l" pos="1055196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971800" y="1433520"/>
            <a:ext cx="149400" cy="54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971800" y="1622520"/>
            <a:ext cx="149400" cy="54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"/>
          <p:cNvGrpSpPr/>
          <p:nvPr/>
        </p:nvGrpSpPr>
        <p:grpSpPr>
          <a:xfrm>
            <a:off x="2286000" y="2514600"/>
            <a:ext cx="369720" cy="85320"/>
            <a:chOff x="2286000" y="2514600"/>
            <a:chExt cx="369720" cy="85320"/>
          </a:xfrm>
        </p:grpSpPr>
        <p:sp>
          <p:nvSpPr>
            <p:cNvPr id="72" name=""/>
            <p:cNvSpPr/>
            <p:nvPr/>
          </p:nvSpPr>
          <p:spPr>
            <a:xfrm>
              <a:off x="2286000" y="2514600"/>
              <a:ext cx="0" cy="85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286000" y="2514600"/>
              <a:ext cx="369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655720" y="2514600"/>
              <a:ext cx="0" cy="85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" name=""/>
          <p:cNvGrpSpPr/>
          <p:nvPr/>
        </p:nvGrpSpPr>
        <p:grpSpPr>
          <a:xfrm>
            <a:off x="3048120" y="2133720"/>
            <a:ext cx="369720" cy="85320"/>
            <a:chOff x="3048120" y="2133720"/>
            <a:chExt cx="369720" cy="85320"/>
          </a:xfrm>
        </p:grpSpPr>
        <p:sp>
          <p:nvSpPr>
            <p:cNvPr id="76" name=""/>
            <p:cNvSpPr/>
            <p:nvPr/>
          </p:nvSpPr>
          <p:spPr>
            <a:xfrm>
              <a:off x="3048120" y="2133720"/>
              <a:ext cx="0" cy="85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048120" y="2133720"/>
              <a:ext cx="369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417840" y="2133720"/>
              <a:ext cx="0" cy="85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9" name=""/>
          <p:cNvSpPr/>
          <p:nvPr/>
        </p:nvSpPr>
        <p:spPr>
          <a:xfrm>
            <a:off x="901080" y="1542960"/>
            <a:ext cx="266040" cy="239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rot="19676400">
            <a:off x="4800960" y="3839760"/>
            <a:ext cx="1461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-cadher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19676400">
            <a:off x="5694840" y="3771720"/>
            <a:ext cx="148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α-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rot="19676400">
            <a:off x="6532920" y="3771720"/>
            <a:ext cx="148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β-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878000" y="1542960"/>
            <a:ext cx="266040" cy="239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4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4" name=""/>
          <p:cNvGrpSpPr/>
          <p:nvPr/>
        </p:nvGrpSpPr>
        <p:grpSpPr>
          <a:xfrm>
            <a:off x="6985080" y="2070000"/>
            <a:ext cx="369720" cy="85320"/>
            <a:chOff x="6985080" y="2070000"/>
            <a:chExt cx="369720" cy="85320"/>
          </a:xfrm>
        </p:grpSpPr>
        <p:sp>
          <p:nvSpPr>
            <p:cNvPr id="85" name=""/>
            <p:cNvSpPr/>
            <p:nvPr/>
          </p:nvSpPr>
          <p:spPr>
            <a:xfrm>
              <a:off x="6985080" y="2070000"/>
              <a:ext cx="0" cy="85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6985080" y="2070000"/>
              <a:ext cx="369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7354800" y="2070000"/>
              <a:ext cx="0" cy="85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"/>
          <p:cNvGrpSpPr/>
          <p:nvPr/>
        </p:nvGrpSpPr>
        <p:grpSpPr>
          <a:xfrm>
            <a:off x="6197760" y="2374920"/>
            <a:ext cx="369720" cy="85320"/>
            <a:chOff x="6197760" y="2374920"/>
            <a:chExt cx="369720" cy="85320"/>
          </a:xfrm>
        </p:grpSpPr>
        <p:sp>
          <p:nvSpPr>
            <p:cNvPr id="89" name=""/>
            <p:cNvSpPr/>
            <p:nvPr/>
          </p:nvSpPr>
          <p:spPr>
            <a:xfrm>
              <a:off x="6197760" y="2374920"/>
              <a:ext cx="0" cy="85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6197760" y="2374920"/>
              <a:ext cx="369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6567480" y="2374920"/>
              <a:ext cx="0" cy="85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"/>
          <p:cNvGrpSpPr/>
          <p:nvPr/>
        </p:nvGrpSpPr>
        <p:grpSpPr>
          <a:xfrm>
            <a:off x="5397480" y="3124080"/>
            <a:ext cx="370080" cy="85320"/>
            <a:chOff x="5397480" y="3124080"/>
            <a:chExt cx="370080" cy="85320"/>
          </a:xfrm>
        </p:grpSpPr>
        <p:sp>
          <p:nvSpPr>
            <p:cNvPr id="93" name=""/>
            <p:cNvSpPr/>
            <p:nvPr/>
          </p:nvSpPr>
          <p:spPr>
            <a:xfrm>
              <a:off x="5397480" y="3124080"/>
              <a:ext cx="0" cy="85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5397480" y="3124080"/>
              <a:ext cx="370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5767560" y="3124080"/>
              <a:ext cx="0" cy="85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6" name=""/>
          <p:cNvSpPr/>
          <p:nvPr/>
        </p:nvSpPr>
        <p:spPr>
          <a:xfrm>
            <a:off x="6705720" y="1433520"/>
            <a:ext cx="149040" cy="54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6705720" y="1622520"/>
            <a:ext cx="149040" cy="54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6400800" y="380880"/>
            <a:ext cx="228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rot="16200000">
            <a:off x="4526640" y="2544840"/>
            <a:ext cx="54504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ΔC</a:t>
            </a: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</a:rPr>
              <a:t>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02T16:58:23Z</dcterms:created>
  <dc:creator>MD Anderson Cancer Center</dc:creator>
  <dc:description/>
  <dc:language>en-US</dc:language>
  <cp:lastModifiedBy>MD Anderson Cancer Center</cp:lastModifiedBy>
  <cp:lastPrinted>2010-10-08T17:56:47Z</cp:lastPrinted>
  <dcterms:modified xsi:type="dcterms:W3CDTF">2010-10-08T17:59:33Z</dcterms:modified>
  <cp:revision>19</cp:revision>
  <dc:subject/>
  <dc:title>Slide 1</dc:title>
</cp:coreProperties>
</file>